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D41482-84C3-4B79-AF7E-809CF362FF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D5BF13-F2C5-45CB-879A-5995D51374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C36D67-21D2-49BB-A46E-D038FA7990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D8F4CD-DBA5-45B4-8688-94CCC1954E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EF0501-0C15-48F5-B302-C39805A2FD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9B901-8B9A-4945-8DC7-87E8CFD0D1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66DBC-6195-45AA-874D-4FB4D668D9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28ADE-E4DE-4B8A-9550-BB6FCB6541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C166A-4F2F-42B9-B763-D09A5E8A3A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4FCB4-CBAE-4DDF-B23E-1746ACD5B6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DAE814-12E4-4B2D-95D7-E380B7FE94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C4C86C-8CC2-4CC2-B346-51E52E2C8E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7376F2-8BD4-4682-89F4-BAC2519B85E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427840" y="828720"/>
            <a:ext cx="4306320" cy="4861080"/>
            <a:chOff x="2427840" y="828720"/>
            <a:chExt cx="4306320" cy="4861080"/>
          </a:xfrm>
        </p:grpSpPr>
        <p:sp>
          <p:nvSpPr>
            <p:cNvPr id="42" name=""/>
            <p:cNvSpPr/>
            <p:nvPr/>
          </p:nvSpPr>
          <p:spPr>
            <a:xfrm>
              <a:off x="3038400" y="1295280"/>
              <a:ext cx="2847960" cy="10191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038400" y="2057400"/>
              <a:ext cx="2847960" cy="144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038400" y="1809720"/>
              <a:ext cx="2847960" cy="144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038400" y="1552680"/>
              <a:ext cx="2847960" cy="144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038400" y="1295280"/>
              <a:ext cx="2847960" cy="180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114720" y="1523880"/>
              <a:ext cx="104760" cy="7905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467160" y="2247840"/>
              <a:ext cx="104760" cy="666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828960" y="2305080"/>
              <a:ext cx="104760" cy="9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181400" y="2305080"/>
              <a:ext cx="104760" cy="9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543560" y="2305080"/>
              <a:ext cx="104760" cy="9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896000" y="2305080"/>
              <a:ext cx="104760" cy="9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248440" y="2305080"/>
              <a:ext cx="104760" cy="9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227400" y="1789200"/>
              <a:ext cx="95400" cy="5331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219480" y="1781280"/>
              <a:ext cx="95400" cy="5331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573360" y="2220840"/>
              <a:ext cx="104760" cy="9540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929040" y="2300400"/>
              <a:ext cx="9540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933720" y="2305080"/>
              <a:ext cx="95400" cy="93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038400" y="1295280"/>
              <a:ext cx="1800" cy="1019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000240" y="2314440"/>
              <a:ext cx="38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000240" y="2057400"/>
              <a:ext cx="38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000240" y="1809720"/>
              <a:ext cx="38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000240" y="1552680"/>
              <a:ext cx="38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000240" y="1295280"/>
              <a:ext cx="38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038400" y="2314440"/>
              <a:ext cx="2847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3038400" y="2314440"/>
              <a:ext cx="180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V="1">
              <a:off x="3390840" y="2314440"/>
              <a:ext cx="180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3753000" y="231444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4105440" y="231444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4467240" y="231444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V="1">
              <a:off x="4819680" y="231444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5172120" y="231444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V="1">
              <a:off x="5533920" y="2314440"/>
              <a:ext cx="180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5886360" y="2314440"/>
              <a:ext cx="180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631680" y="828720"/>
              <a:ext cx="1896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Donor 1034 (24 hr post stim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876040" y="223848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809080" y="198108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742120" y="1733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742120" y="14763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742120" y="12193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rot="18900000">
              <a:off x="2729160" y="2574360"/>
              <a:ext cx="473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R-848 [3]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rot="18900000">
              <a:off x="3081600" y="2574360"/>
              <a:ext cx="473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R-848 [1]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rot="18900000">
              <a:off x="3352680" y="2607840"/>
              <a:ext cx="5691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R-848 [0.3]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rot="18900000">
              <a:off x="3714480" y="2607840"/>
              <a:ext cx="5691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R-848 [0.1]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rot="18900000">
              <a:off x="4273920" y="2515680"/>
              <a:ext cx="342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DMS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rot="18900000">
              <a:off x="4635720" y="2515680"/>
              <a:ext cx="342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DMS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rot="18900000">
              <a:off x="4921200" y="2548800"/>
              <a:ext cx="407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Mediu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rot="18900000">
              <a:off x="5273640" y="2548800"/>
              <a:ext cx="407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Mediu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rot="16200000">
              <a:off x="2150280" y="1728000"/>
              <a:ext cx="919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IL-12p70 [pg/mL]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5991120" y="1609560"/>
              <a:ext cx="733680" cy="38124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6039000" y="1676520"/>
              <a:ext cx="66600" cy="666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6140880" y="1638360"/>
              <a:ext cx="570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No vaccin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6033960" y="1862280"/>
              <a:ext cx="66960" cy="666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6039000" y="1866960"/>
              <a:ext cx="66600" cy="66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6141600" y="1828800"/>
              <a:ext cx="41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Vaccin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067200" y="4038480"/>
              <a:ext cx="2762280" cy="1000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067200" y="4838760"/>
              <a:ext cx="2762280" cy="144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067200" y="4638600"/>
              <a:ext cx="2762280" cy="180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067200" y="4438800"/>
              <a:ext cx="2762280" cy="144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067200" y="4238640"/>
              <a:ext cx="2762280" cy="144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3067200" y="4038480"/>
              <a:ext cx="2762280" cy="180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133800" y="4610160"/>
              <a:ext cx="104760" cy="4284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476520" y="4800600"/>
              <a:ext cx="104760" cy="2379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240000" y="4052880"/>
              <a:ext cx="95400" cy="9810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238560" y="4057560"/>
              <a:ext cx="95040" cy="981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583080" y="4938840"/>
              <a:ext cx="104760" cy="950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581280" y="4943520"/>
              <a:ext cx="104760" cy="95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941640" y="4992840"/>
              <a:ext cx="95400" cy="4752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3940200" y="4997520"/>
              <a:ext cx="95400" cy="47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3067200" y="4038480"/>
              <a:ext cx="1440" cy="1000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3029040" y="5038560"/>
              <a:ext cx="38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029040" y="4838760"/>
              <a:ext cx="38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029040" y="4638600"/>
              <a:ext cx="38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029040" y="4438800"/>
              <a:ext cx="38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029040" y="4238640"/>
              <a:ext cx="38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029040" y="4038480"/>
              <a:ext cx="38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3067200" y="5038560"/>
              <a:ext cx="2762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 flipV="1">
              <a:off x="3067200" y="503856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V="1">
              <a:off x="3409920" y="503856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flipV="1">
              <a:off x="3762360" y="503856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V="1">
              <a:off x="4105440" y="503856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flipV="1">
              <a:off x="4448160" y="503856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flipV="1">
              <a:off x="4791240" y="503856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 flipV="1">
              <a:off x="5143680" y="503856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flipV="1">
              <a:off x="5486400" y="503856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 flipV="1">
              <a:off x="5829480" y="5038560"/>
              <a:ext cx="144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631680" y="3571920"/>
              <a:ext cx="1896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Donor 1034 (48 hr post stim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904840" y="49626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838240" y="4762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770920" y="45626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770920" y="43624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2770920" y="41623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2770920" y="39625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 rot="18900000">
              <a:off x="2730240" y="5300280"/>
              <a:ext cx="52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-848 [3]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rot="18900000">
              <a:off x="3072960" y="5300280"/>
              <a:ext cx="52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-848 [1]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rot="18900000">
              <a:off x="3332880" y="5338080"/>
              <a:ext cx="625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-848 [0.3]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rot="18900000">
              <a:off x="3675960" y="5338080"/>
              <a:ext cx="625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-848 [0.1]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rot="18900000">
              <a:off x="4216680" y="5262120"/>
              <a:ext cx="38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rot="18900000">
              <a:off x="4559760" y="5262120"/>
              <a:ext cx="38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rot="18900000">
              <a:off x="4855320" y="5284800"/>
              <a:ext cx="44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ed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rot="18900000">
              <a:off x="5198400" y="5284440"/>
              <a:ext cx="44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ed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rot="16200000">
              <a:off x="2111400" y="4443840"/>
              <a:ext cx="1015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L-12p70 [pg/mL]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5934240" y="4334040"/>
              <a:ext cx="799920" cy="39996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5981760" y="4410000"/>
              <a:ext cx="66600" cy="666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6085800" y="4362480"/>
              <a:ext cx="627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o vaccin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5977080" y="4605480"/>
              <a:ext cx="66600" cy="666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5981760" y="4610160"/>
              <a:ext cx="66600" cy="66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6086160" y="4562640"/>
              <a:ext cx="450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Vaccin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427840" y="2381400"/>
              <a:ext cx="48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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2443680" y="5105520"/>
              <a:ext cx="48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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04T21:26:09Z</dcterms:created>
  <dc:creator> </dc:creator>
  <dc:description/>
  <dc:language>en-US</dc:language>
  <cp:lastModifiedBy> </cp:lastModifiedBy>
  <dcterms:modified xsi:type="dcterms:W3CDTF">2007-01-19T19:11:37Z</dcterms:modified>
  <cp:revision>51</cp:revision>
  <dc:subject/>
  <dc:title>Slide 1</dc:title>
</cp:coreProperties>
</file>